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5B7D63-183B-42DA-8502-01AAB7CCE969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3ED46B-BED3-4D86-A34C-2172FFC5E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8007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Allele</a:t>
            </a:r>
            <a:r>
              <a:rPr lang="en-US" baseline="0" dirty="0" smtClean="0"/>
              <a:t> effects for </a:t>
            </a:r>
            <a:r>
              <a:rPr lang="en-US" baseline="0" dirty="0" err="1" smtClean="0"/>
              <a:t>Chr</a:t>
            </a:r>
            <a:r>
              <a:rPr lang="en-US" baseline="0" dirty="0" smtClean="0"/>
              <a:t> 18 Baseline PC150 QT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C24DA28-3FEE-A647-8B34-4045B99FD97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9232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CD1A-910D-4868-85C5-4712C7FCACBE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89672-576F-4146-BBFF-7000810A0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883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CD1A-910D-4868-85C5-4712C7FCACBE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89672-576F-4146-BBFF-7000810A0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622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CD1A-910D-4868-85C5-4712C7FCACBE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89672-576F-4146-BBFF-7000810A0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272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CD1A-910D-4868-85C5-4712C7FCACBE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89672-576F-4146-BBFF-7000810A0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388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CD1A-910D-4868-85C5-4712C7FCACBE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89672-576F-4146-BBFF-7000810A0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247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CD1A-910D-4868-85C5-4712C7FCACBE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89672-576F-4146-BBFF-7000810A0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293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CD1A-910D-4868-85C5-4712C7FCACBE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89672-576F-4146-BBFF-7000810A0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832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CD1A-910D-4868-85C5-4712C7FCACBE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89672-576F-4146-BBFF-7000810A0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1517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CD1A-910D-4868-85C5-4712C7FCACBE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89672-576F-4146-BBFF-7000810A0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234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CD1A-910D-4868-85C5-4712C7FCACBE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89672-576F-4146-BBFF-7000810A0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353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CD1A-910D-4868-85C5-4712C7FCACBE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089672-576F-4146-BBFF-7000810A0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17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0CD1A-910D-4868-85C5-4712C7FCACBE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089672-576F-4146-BBFF-7000810A0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071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28831" y="68267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Figure S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" name="Picture 3" descr="FigS5_Chr18_AEP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0176" y="990600"/>
            <a:ext cx="5889625" cy="47117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728831" y="5541912"/>
            <a:ext cx="876174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5. Allele effects for </a:t>
            </a:r>
            <a:r>
              <a:rPr lang="en-US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hr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18 baseline PC</a:t>
            </a:r>
            <a:r>
              <a:rPr lang="en-US" baseline="-25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50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QTL. Only data for homozygotes are shown (n=105).</a:t>
            </a:r>
          </a:p>
        </p:txBody>
      </p:sp>
    </p:spTree>
    <p:extLst>
      <p:ext uri="{BB962C8B-B14F-4D97-AF65-F5344CB8AC3E}">
        <p14:creationId xmlns:p14="http://schemas.microsoft.com/office/powerpoint/2010/main" val="32295505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MS Mincho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Wolper</dc:creator>
  <cp:lastModifiedBy>Sarah Wolper</cp:lastModifiedBy>
  <cp:revision>1</cp:revision>
  <dcterms:created xsi:type="dcterms:W3CDTF">2016-07-20T19:37:09Z</dcterms:created>
  <dcterms:modified xsi:type="dcterms:W3CDTF">2016-07-20T19:37:22Z</dcterms:modified>
</cp:coreProperties>
</file>